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8" r:id="rId2"/>
    <p:sldId id="278" r:id="rId3"/>
    <p:sldId id="308" r:id="rId4"/>
    <p:sldId id="282" r:id="rId5"/>
    <p:sldId id="285" r:id="rId6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osomi koji" initials="hk" lastIdx="1" clrIdx="0">
    <p:extLst>
      <p:ext uri="{19B8F6BF-5375-455C-9EA6-DF929625EA0E}">
        <p15:presenceInfo xmlns:p15="http://schemas.microsoft.com/office/powerpoint/2012/main" userId="27f76ab953789e2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99"/>
    <a:srgbClr val="FF9933"/>
    <a:srgbClr val="0000FF"/>
    <a:srgbClr val="FF6600"/>
    <a:srgbClr val="FF3300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21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06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8501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17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02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469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568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351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88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7033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57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379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301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DCCDA-1FB8-4EBE-823C-44257236D388}" type="datetimeFigureOut">
              <a:rPr kumimoji="1" lang="ja-JP" altLang="en-US" smtClean="0"/>
              <a:t>2025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CE09E-0F83-4B27-9B7A-F3B99F8CED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917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702DCEA-4B3D-20D8-884B-7ABDFBB2976A}"/>
              </a:ext>
            </a:extLst>
          </p:cNvPr>
          <p:cNvSpPr txBox="1"/>
          <p:nvPr/>
        </p:nvSpPr>
        <p:spPr>
          <a:xfrm>
            <a:off x="6801970" y="152400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pplementary Table</a:t>
            </a:r>
            <a:r>
              <a:rPr kumimoji="1" lang="ja-JP" altLang="en-US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14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9760B8A-1D98-8801-0E92-CFA2D3CA1DEC}"/>
              </a:ext>
            </a:extLst>
          </p:cNvPr>
          <p:cNvSpPr txBox="1"/>
          <p:nvPr/>
        </p:nvSpPr>
        <p:spPr>
          <a:xfrm>
            <a:off x="1160962" y="1662861"/>
            <a:ext cx="2920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Participant informatio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97EF180-9B41-446B-8307-1F9719C6101C}"/>
              </a:ext>
            </a:extLst>
          </p:cNvPr>
          <p:cNvSpPr txBox="1"/>
          <p:nvPr/>
        </p:nvSpPr>
        <p:spPr>
          <a:xfrm>
            <a:off x="6319041" y="1932550"/>
            <a:ext cx="11128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bjects without</a:t>
            </a:r>
          </a:p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usobacterium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8E9F703-7859-FDC2-A012-9D726EE6850B}"/>
              </a:ext>
            </a:extLst>
          </p:cNvPr>
          <p:cNvSpPr txBox="1"/>
          <p:nvPr/>
        </p:nvSpPr>
        <p:spPr>
          <a:xfrm>
            <a:off x="4687441" y="1932550"/>
            <a:ext cx="10294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bjects with</a:t>
            </a:r>
          </a:p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usobacterium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BF30638-6DDC-3262-2359-BE228899F774}"/>
              </a:ext>
            </a:extLst>
          </p:cNvPr>
          <p:cNvSpPr txBox="1"/>
          <p:nvPr/>
        </p:nvSpPr>
        <p:spPr>
          <a:xfrm>
            <a:off x="1135562" y="2775273"/>
            <a:ext cx="12795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years,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4FDBCE6-AC44-465C-922A-C24002470E99}"/>
              </a:ext>
            </a:extLst>
          </p:cNvPr>
          <p:cNvSpPr txBox="1"/>
          <p:nvPr/>
        </p:nvSpPr>
        <p:spPr>
          <a:xfrm>
            <a:off x="1135562" y="2569366"/>
            <a:ext cx="9236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le/Femal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F544C8F-4BD0-B79B-6889-274326826B95}"/>
              </a:ext>
            </a:extLst>
          </p:cNvPr>
          <p:cNvSpPr txBox="1"/>
          <p:nvPr/>
        </p:nvSpPr>
        <p:spPr>
          <a:xfrm>
            <a:off x="1135562" y="3135069"/>
            <a:ext cx="12923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ody mass index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kg/m</a:t>
            </a:r>
            <a:r>
              <a:rPr kumimoji="1"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85A984D-D7AC-2F22-39E1-9F07D2D34F8F}"/>
              </a:ext>
            </a:extLst>
          </p:cNvPr>
          <p:cNvSpPr txBox="1"/>
          <p:nvPr/>
        </p:nvSpPr>
        <p:spPr>
          <a:xfrm>
            <a:off x="1135562" y="3494865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iseas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2BF8E9F-91E7-253E-2DF9-85CA8592D887}"/>
              </a:ext>
            </a:extLst>
          </p:cNvPr>
          <p:cNvSpPr txBox="1"/>
          <p:nvPr/>
        </p:nvSpPr>
        <p:spPr>
          <a:xfrm>
            <a:off x="1394442" y="3700772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A3C2457-2DAC-6C8E-BADC-3F079C9C11EC}"/>
              </a:ext>
            </a:extLst>
          </p:cNvPr>
          <p:cNvSpPr txBox="1"/>
          <p:nvPr/>
        </p:nvSpPr>
        <p:spPr>
          <a:xfrm>
            <a:off x="1394442" y="3906679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yslipidemia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F82E15A9-34B6-09D6-0585-2EB5A659615E}"/>
              </a:ext>
            </a:extLst>
          </p:cNvPr>
          <p:cNvCxnSpPr/>
          <p:nvPr/>
        </p:nvCxnSpPr>
        <p:spPr>
          <a:xfrm>
            <a:off x="1123415" y="5196689"/>
            <a:ext cx="66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E2A08222-7BA0-D989-53BE-55AE831DFC7B}"/>
              </a:ext>
            </a:extLst>
          </p:cNvPr>
          <p:cNvCxnSpPr/>
          <p:nvPr/>
        </p:nvCxnSpPr>
        <p:spPr>
          <a:xfrm>
            <a:off x="1123415" y="1909063"/>
            <a:ext cx="66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535C6B0B-C705-C40A-B6ED-23A30FF34758}"/>
              </a:ext>
            </a:extLst>
          </p:cNvPr>
          <p:cNvCxnSpPr/>
          <p:nvPr/>
        </p:nvCxnSpPr>
        <p:spPr>
          <a:xfrm>
            <a:off x="1123415" y="2356148"/>
            <a:ext cx="66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45D874F-C942-0E24-B93E-406DAC9D6040}"/>
              </a:ext>
            </a:extLst>
          </p:cNvPr>
          <p:cNvSpPr txBox="1"/>
          <p:nvPr/>
        </p:nvSpPr>
        <p:spPr>
          <a:xfrm>
            <a:off x="1135562" y="2363459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2683549-4494-ECE6-7459-25DB5467C478}"/>
              </a:ext>
            </a:extLst>
          </p:cNvPr>
          <p:cNvSpPr txBox="1"/>
          <p:nvPr/>
        </p:nvSpPr>
        <p:spPr>
          <a:xfrm>
            <a:off x="5004034" y="2363459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62358E5-71C1-25F8-A60E-B61206C5F555}"/>
              </a:ext>
            </a:extLst>
          </p:cNvPr>
          <p:cNvSpPr txBox="1"/>
          <p:nvPr/>
        </p:nvSpPr>
        <p:spPr>
          <a:xfrm>
            <a:off x="6677311" y="2363459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1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0C1F3B6-63B4-A93D-60A5-6341739E92C5}"/>
              </a:ext>
            </a:extLst>
          </p:cNvPr>
          <p:cNvSpPr txBox="1"/>
          <p:nvPr/>
        </p:nvSpPr>
        <p:spPr>
          <a:xfrm>
            <a:off x="4667402" y="2775273"/>
            <a:ext cx="1069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.6 ± 12.1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ange: 19–64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8DCEFE8-2748-2A1E-7864-0C36CCDF2287}"/>
              </a:ext>
            </a:extLst>
          </p:cNvPr>
          <p:cNvSpPr txBox="1"/>
          <p:nvPr/>
        </p:nvSpPr>
        <p:spPr>
          <a:xfrm>
            <a:off x="6340679" y="2775273"/>
            <a:ext cx="1069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2.3 ± 11.6</a:t>
            </a:r>
            <a:endParaRPr kumimoji="1" lang="en-US" altLang="ja-JP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ange: 20–65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33F8C16-5052-2DCE-28CD-3DEC139578B4}"/>
              </a:ext>
            </a:extLst>
          </p:cNvPr>
          <p:cNvSpPr txBox="1"/>
          <p:nvPr/>
        </p:nvSpPr>
        <p:spPr>
          <a:xfrm>
            <a:off x="4561605" y="3135069"/>
            <a:ext cx="12811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3.7 ± 4.3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ange: 16.6–39.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03469D4-AA6F-0709-9B0F-B5763FAEB04E}"/>
              </a:ext>
            </a:extLst>
          </p:cNvPr>
          <p:cNvSpPr txBox="1"/>
          <p:nvPr/>
        </p:nvSpPr>
        <p:spPr>
          <a:xfrm>
            <a:off x="6234884" y="3135069"/>
            <a:ext cx="12811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2.7 ± 3.9</a:t>
            </a:r>
            <a:endParaRPr kumimoji="1" lang="en-US" altLang="ja-JP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ange: 15.9–42.9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CC186B7-D138-5640-8527-66D55D5122F6}"/>
              </a:ext>
            </a:extLst>
          </p:cNvPr>
          <p:cNvSpPr txBox="1"/>
          <p:nvPr/>
        </p:nvSpPr>
        <p:spPr>
          <a:xfrm>
            <a:off x="4850947" y="3700772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9 (16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6AA819F-80B7-CA95-8C21-A62B8273AD14}"/>
              </a:ext>
            </a:extLst>
          </p:cNvPr>
          <p:cNvSpPr txBox="1"/>
          <p:nvPr/>
        </p:nvSpPr>
        <p:spPr>
          <a:xfrm>
            <a:off x="6594757" y="3700772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 (7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08DF51D-63C7-8FF7-9836-C09685C137AC}"/>
              </a:ext>
            </a:extLst>
          </p:cNvPr>
          <p:cNvSpPr txBox="1"/>
          <p:nvPr/>
        </p:nvSpPr>
        <p:spPr>
          <a:xfrm>
            <a:off x="4850947" y="3906679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 (17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38A2D23-0716-A28D-8E84-B54EC8173EB2}"/>
              </a:ext>
            </a:extLst>
          </p:cNvPr>
          <p:cNvSpPr txBox="1"/>
          <p:nvPr/>
        </p:nvSpPr>
        <p:spPr>
          <a:xfrm>
            <a:off x="6524225" y="3906679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4 (21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5F75C2E-AAB3-4328-4049-968836656E4D}"/>
              </a:ext>
            </a:extLst>
          </p:cNvPr>
          <p:cNvSpPr txBox="1"/>
          <p:nvPr/>
        </p:nvSpPr>
        <p:spPr>
          <a:xfrm>
            <a:off x="4951136" y="2569366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98/2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73F2AC9-68C3-FADD-705A-890A7D5AFCF4}"/>
              </a:ext>
            </a:extLst>
          </p:cNvPr>
          <p:cNvSpPr txBox="1"/>
          <p:nvPr/>
        </p:nvSpPr>
        <p:spPr>
          <a:xfrm>
            <a:off x="6624414" y="2569366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9/37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AC43193-055F-D11D-1DBE-A135B827F74D}"/>
              </a:ext>
            </a:extLst>
          </p:cNvPr>
          <p:cNvSpPr txBox="1"/>
          <p:nvPr/>
        </p:nvSpPr>
        <p:spPr>
          <a:xfrm>
            <a:off x="3015487" y="2009495"/>
            <a:ext cx="971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otal subjects</a:t>
            </a:r>
            <a:endParaRPr kumimoji="1" lang="en-US" altLang="ja-JP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28FF804-EE52-C327-A1DB-FEE754FA5D0A}"/>
              </a:ext>
            </a:extLst>
          </p:cNvPr>
          <p:cNvSpPr txBox="1"/>
          <p:nvPr/>
        </p:nvSpPr>
        <p:spPr>
          <a:xfrm>
            <a:off x="3306841" y="2363459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3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670E527-AB9A-9712-8059-DE7DD9D8BFF3}"/>
              </a:ext>
            </a:extLst>
          </p:cNvPr>
          <p:cNvSpPr txBox="1"/>
          <p:nvPr/>
        </p:nvSpPr>
        <p:spPr>
          <a:xfrm>
            <a:off x="2960420" y="2775273"/>
            <a:ext cx="1069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1.4 ± 11.9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ange: 19–65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BA3D520-BB72-6977-60F7-8F048365D5EF}"/>
              </a:ext>
            </a:extLst>
          </p:cNvPr>
          <p:cNvSpPr txBox="1"/>
          <p:nvPr/>
        </p:nvSpPr>
        <p:spPr>
          <a:xfrm>
            <a:off x="2854626" y="3135069"/>
            <a:ext cx="12811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3.2 ± 4.2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ange: 15.9–42.9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4C6824E-9623-01E8-E4C9-990FC47A4A52}"/>
              </a:ext>
            </a:extLst>
          </p:cNvPr>
          <p:cNvSpPr txBox="1"/>
          <p:nvPr/>
        </p:nvSpPr>
        <p:spPr>
          <a:xfrm>
            <a:off x="3143966" y="3700772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7 (11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7C9BB6F-DB76-E616-4BC3-EB38546DD4D0}"/>
              </a:ext>
            </a:extLst>
          </p:cNvPr>
          <p:cNvSpPr txBox="1"/>
          <p:nvPr/>
        </p:nvSpPr>
        <p:spPr>
          <a:xfrm>
            <a:off x="3143966" y="3906679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4 (19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DAC620B-CCE5-96DA-9A92-8D2F53BCCD72}"/>
              </a:ext>
            </a:extLst>
          </p:cNvPr>
          <p:cNvSpPr txBox="1"/>
          <p:nvPr/>
        </p:nvSpPr>
        <p:spPr>
          <a:xfrm>
            <a:off x="3208892" y="2569366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77/59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68C09A43-A7CA-1657-E7DC-D27A164F7BAB}"/>
              </a:ext>
            </a:extLst>
          </p:cNvPr>
          <p:cNvSpPr txBox="1"/>
          <p:nvPr/>
        </p:nvSpPr>
        <p:spPr>
          <a:xfrm>
            <a:off x="1394442" y="4112586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iabetes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F7B1136-D411-5513-2F0D-8BC0E6BCF28F}"/>
              </a:ext>
            </a:extLst>
          </p:cNvPr>
          <p:cNvSpPr txBox="1"/>
          <p:nvPr/>
        </p:nvSpPr>
        <p:spPr>
          <a:xfrm>
            <a:off x="4921479" y="4112586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 (5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564153D-3E14-E09A-9FD3-4383802526B5}"/>
              </a:ext>
            </a:extLst>
          </p:cNvPr>
          <p:cNvSpPr txBox="1"/>
          <p:nvPr/>
        </p:nvSpPr>
        <p:spPr>
          <a:xfrm>
            <a:off x="6541858" y="4112586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 (0.9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D1295EB1-1E89-1F2C-0EBC-C4FD699B769C}"/>
              </a:ext>
            </a:extLst>
          </p:cNvPr>
          <p:cNvSpPr txBox="1"/>
          <p:nvPr/>
        </p:nvSpPr>
        <p:spPr>
          <a:xfrm>
            <a:off x="3214498" y="4112586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 (3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F35DAFA-285D-1102-081D-0252AAAA6824}"/>
              </a:ext>
            </a:extLst>
          </p:cNvPr>
          <p:cNvSpPr txBox="1"/>
          <p:nvPr/>
        </p:nvSpPr>
        <p:spPr>
          <a:xfrm>
            <a:off x="1394442" y="4320101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lcerative colitis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85E97E33-788E-CEFE-E4B9-D5D6256CEE5E}"/>
              </a:ext>
            </a:extLst>
          </p:cNvPr>
          <p:cNvSpPr txBox="1"/>
          <p:nvPr/>
        </p:nvSpPr>
        <p:spPr>
          <a:xfrm>
            <a:off x="4921479" y="4320101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9C44C93-D92A-3F4A-D04C-F8EB5CAB5C77}"/>
              </a:ext>
            </a:extLst>
          </p:cNvPr>
          <p:cNvSpPr txBox="1"/>
          <p:nvPr/>
        </p:nvSpPr>
        <p:spPr>
          <a:xfrm>
            <a:off x="6594757" y="4320101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7FDF4FB-77A5-B854-6011-CE8B50C44B55}"/>
              </a:ext>
            </a:extLst>
          </p:cNvPr>
          <p:cNvSpPr txBox="1"/>
          <p:nvPr/>
        </p:nvSpPr>
        <p:spPr>
          <a:xfrm>
            <a:off x="3214498" y="4320101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EFF34607-2D11-2ED5-E676-12E1FDBD0CE1}"/>
              </a:ext>
            </a:extLst>
          </p:cNvPr>
          <p:cNvSpPr txBox="1"/>
          <p:nvPr/>
        </p:nvSpPr>
        <p:spPr>
          <a:xfrm>
            <a:off x="1394442" y="4528884"/>
            <a:ext cx="10999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rohn’s disease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4B30E811-DDE9-8C21-8FD5-7CB7CFD613DB}"/>
              </a:ext>
            </a:extLst>
          </p:cNvPr>
          <p:cNvSpPr txBox="1"/>
          <p:nvPr/>
        </p:nvSpPr>
        <p:spPr>
          <a:xfrm>
            <a:off x="4921479" y="4528884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279A746A-7A62-E283-FBFA-080A55FF9488}"/>
              </a:ext>
            </a:extLst>
          </p:cNvPr>
          <p:cNvSpPr txBox="1"/>
          <p:nvPr/>
        </p:nvSpPr>
        <p:spPr>
          <a:xfrm>
            <a:off x="6594757" y="4528884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B8F745F-3B00-C4C0-FEF2-A2B0AA8BE0F2}"/>
              </a:ext>
            </a:extLst>
          </p:cNvPr>
          <p:cNvSpPr txBox="1"/>
          <p:nvPr/>
        </p:nvSpPr>
        <p:spPr>
          <a:xfrm>
            <a:off x="3214498" y="4528884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BE9A5500-80C6-4110-CD6C-F018E966A210}"/>
              </a:ext>
            </a:extLst>
          </p:cNvPr>
          <p:cNvSpPr txBox="1"/>
          <p:nvPr/>
        </p:nvSpPr>
        <p:spPr>
          <a:xfrm>
            <a:off x="1394442" y="4736399"/>
            <a:ext cx="1576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rritable bowel syndrome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EA30D369-7610-2311-68E9-4E119F0C0647}"/>
              </a:ext>
            </a:extLst>
          </p:cNvPr>
          <p:cNvSpPr txBox="1"/>
          <p:nvPr/>
        </p:nvSpPr>
        <p:spPr>
          <a:xfrm>
            <a:off x="4921479" y="4736399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00BAB380-C23C-F8DD-1A50-B09655EB1841}"/>
              </a:ext>
            </a:extLst>
          </p:cNvPr>
          <p:cNvSpPr txBox="1"/>
          <p:nvPr/>
        </p:nvSpPr>
        <p:spPr>
          <a:xfrm>
            <a:off x="6541858" y="473639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 (1.7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83B92DAD-D187-882A-E24C-E9F682C861D6}"/>
              </a:ext>
            </a:extLst>
          </p:cNvPr>
          <p:cNvSpPr txBox="1"/>
          <p:nvPr/>
        </p:nvSpPr>
        <p:spPr>
          <a:xfrm>
            <a:off x="3161599" y="473639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 (0.8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939025FE-C737-15F2-A690-8F6B682B5016}"/>
              </a:ext>
            </a:extLst>
          </p:cNvPr>
          <p:cNvSpPr txBox="1"/>
          <p:nvPr/>
        </p:nvSpPr>
        <p:spPr>
          <a:xfrm>
            <a:off x="1394690" y="4944959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kumimoji="1" lang="ja-JP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A9FD8E18-4B05-99E3-D545-2A13205E48D3}"/>
              </a:ext>
            </a:extLst>
          </p:cNvPr>
          <p:cNvSpPr txBox="1"/>
          <p:nvPr/>
        </p:nvSpPr>
        <p:spPr>
          <a:xfrm>
            <a:off x="4868828" y="494495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 (0.8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F10B03D-C9B4-994E-DE90-F958707488DC}"/>
              </a:ext>
            </a:extLst>
          </p:cNvPr>
          <p:cNvSpPr txBox="1"/>
          <p:nvPr/>
        </p:nvSpPr>
        <p:spPr>
          <a:xfrm>
            <a:off x="6595005" y="4944959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(0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685C07DB-7503-FDC7-DF09-7227C2A2036D}"/>
              </a:ext>
            </a:extLst>
          </p:cNvPr>
          <p:cNvSpPr txBox="1"/>
          <p:nvPr/>
        </p:nvSpPr>
        <p:spPr>
          <a:xfrm>
            <a:off x="3161847" y="494495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 (0.4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9A84590-B0BA-C854-E3EC-DDEDA07018A7}"/>
              </a:ext>
            </a:extLst>
          </p:cNvPr>
          <p:cNvSpPr txBox="1"/>
          <p:nvPr/>
        </p:nvSpPr>
        <p:spPr>
          <a:xfrm>
            <a:off x="1160962" y="5203999"/>
            <a:ext cx="4283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This table presents data from our previous cross-sectional study (ref. 18)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62848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図 55">
            <a:extLst>
              <a:ext uri="{FF2B5EF4-FFF2-40B4-BE49-F238E27FC236}">
                <a16:creationId xmlns:a16="http://schemas.microsoft.com/office/drawing/2014/main" id="{874E4032-A5C7-CF4F-0CF9-BBC1EEC145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5227" y="1910630"/>
            <a:ext cx="1693545" cy="1773555"/>
          </a:xfrm>
          <a:prstGeom prst="rect">
            <a:avLst/>
          </a:prstGeom>
        </p:spPr>
      </p:pic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2DAC8B8B-BB5D-C8FB-4E9A-E5FA9225A5C0}"/>
              </a:ext>
            </a:extLst>
          </p:cNvPr>
          <p:cNvGrpSpPr/>
          <p:nvPr/>
        </p:nvGrpSpPr>
        <p:grpSpPr>
          <a:xfrm>
            <a:off x="3520831" y="1966336"/>
            <a:ext cx="508161" cy="1528263"/>
            <a:chOff x="3914381" y="2432100"/>
            <a:chExt cx="508161" cy="1528263"/>
          </a:xfrm>
        </p:grpSpPr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46F2CD56-F25A-211E-CA82-7F8F844016A6}"/>
                </a:ext>
              </a:extLst>
            </p:cNvPr>
            <p:cNvSpPr txBox="1"/>
            <p:nvPr/>
          </p:nvSpPr>
          <p:spPr>
            <a:xfrm rot="16200000">
              <a:off x="3348842" y="3070301"/>
              <a:ext cx="13773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Butyric acid</a:t>
              </a:r>
              <a:r>
                <a: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(area/IS)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9CB1835C-36E9-4D62-B585-4F3E91212622}"/>
                </a:ext>
              </a:extLst>
            </p:cNvPr>
            <p:cNvSpPr txBox="1"/>
            <p:nvPr/>
          </p:nvSpPr>
          <p:spPr>
            <a:xfrm>
              <a:off x="4167344" y="371414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78FEC3FD-9E24-BB45-792A-0E83C28FEE7E}"/>
                </a:ext>
              </a:extLst>
            </p:cNvPr>
            <p:cNvSpPr txBox="1"/>
            <p:nvPr/>
          </p:nvSpPr>
          <p:spPr>
            <a:xfrm>
              <a:off x="4096812" y="328679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10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F97CAE98-FD38-CAA3-00E9-E5780BDF4142}"/>
                </a:ext>
              </a:extLst>
            </p:cNvPr>
            <p:cNvSpPr txBox="1"/>
            <p:nvPr/>
          </p:nvSpPr>
          <p:spPr>
            <a:xfrm>
              <a:off x="4096811" y="2859447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20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034917D0-C6D6-1E5A-39D7-5617CEF0617B}"/>
                </a:ext>
              </a:extLst>
            </p:cNvPr>
            <p:cNvSpPr txBox="1"/>
            <p:nvPr/>
          </p:nvSpPr>
          <p:spPr>
            <a:xfrm>
              <a:off x="4096812" y="243210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30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76F2FCD-2678-85C2-A0B2-E433ECF144C0}"/>
              </a:ext>
            </a:extLst>
          </p:cNvPr>
          <p:cNvSpPr txBox="1"/>
          <p:nvPr/>
        </p:nvSpPr>
        <p:spPr>
          <a:xfrm>
            <a:off x="3898085" y="3479190"/>
            <a:ext cx="6399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resh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medium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D5D46E50-A964-F2E6-AF38-684C23DFD414}"/>
              </a:ext>
            </a:extLst>
          </p:cNvPr>
          <p:cNvCxnSpPr>
            <a:cxnSpLocks/>
          </p:cNvCxnSpPr>
          <p:nvPr/>
        </p:nvCxnSpPr>
        <p:spPr>
          <a:xfrm>
            <a:off x="4074044" y="3510328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E5D31B3-49BD-C9BB-F930-2E83CCF54A28}"/>
              </a:ext>
            </a:extLst>
          </p:cNvPr>
          <p:cNvSpPr txBox="1"/>
          <p:nvPr/>
        </p:nvSpPr>
        <p:spPr>
          <a:xfrm>
            <a:off x="4426999" y="3479190"/>
            <a:ext cx="7713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Incubation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or 24 h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A720A3AA-DB7C-7D97-A61C-4E2884614462}"/>
              </a:ext>
            </a:extLst>
          </p:cNvPr>
          <p:cNvCxnSpPr>
            <a:cxnSpLocks/>
          </p:cNvCxnSpPr>
          <p:nvPr/>
        </p:nvCxnSpPr>
        <p:spPr>
          <a:xfrm>
            <a:off x="4407681" y="3510328"/>
            <a:ext cx="81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85312597-FA36-AE72-DD9A-78D07FC2EAFA}"/>
              </a:ext>
            </a:extLst>
          </p:cNvPr>
          <p:cNvSpPr txBox="1"/>
          <p:nvPr/>
        </p:nvSpPr>
        <p:spPr>
          <a:xfrm>
            <a:off x="6708483" y="15240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pplementary Figure 1</a:t>
            </a:r>
            <a:endParaRPr kumimoji="1" lang="ja-JP" altLang="en-US" sz="14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2A2911D-022D-AE49-808C-DD86B2664E9C}"/>
              </a:ext>
            </a:extLst>
          </p:cNvPr>
          <p:cNvGrpSpPr/>
          <p:nvPr/>
        </p:nvGrpSpPr>
        <p:grpSpPr>
          <a:xfrm>
            <a:off x="3748774" y="3896365"/>
            <a:ext cx="1707094" cy="542787"/>
            <a:chOff x="9020636" y="-1032624"/>
            <a:chExt cx="1707094" cy="542787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C572271A-66D0-5715-B0C0-37BA035E4778}"/>
                </a:ext>
              </a:extLst>
            </p:cNvPr>
            <p:cNvGrpSpPr/>
            <p:nvPr/>
          </p:nvGrpSpPr>
          <p:grpSpPr>
            <a:xfrm>
              <a:off x="9072976" y="-1032624"/>
              <a:ext cx="1654754" cy="542787"/>
              <a:chOff x="9072976" y="-1032624"/>
              <a:chExt cx="1654754" cy="542787"/>
            </a:xfrm>
          </p:grpSpPr>
          <p:sp>
            <p:nvSpPr>
              <p:cNvPr id="32" name="楕円 31">
                <a:extLst>
                  <a:ext uri="{FF2B5EF4-FFF2-40B4-BE49-F238E27FC236}">
                    <a16:creationId xmlns:a16="http://schemas.microsoft.com/office/drawing/2014/main" id="{A7130235-5615-9D23-2AD0-D9BB2F8816A7}"/>
                  </a:ext>
                </a:extLst>
              </p:cNvPr>
              <p:cNvSpPr/>
              <p:nvPr/>
            </p:nvSpPr>
            <p:spPr>
              <a:xfrm>
                <a:off x="9072976" y="-648948"/>
                <a:ext cx="72000" cy="72000"/>
              </a:xfrm>
              <a:prstGeom prst="ellipse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5" name="楕円 34">
                <a:extLst>
                  <a:ext uri="{FF2B5EF4-FFF2-40B4-BE49-F238E27FC236}">
                    <a16:creationId xmlns:a16="http://schemas.microsoft.com/office/drawing/2014/main" id="{6C70B9B7-9F47-0297-9389-4A72CE4CA184}"/>
                  </a:ext>
                </a:extLst>
              </p:cNvPr>
              <p:cNvSpPr/>
              <p:nvPr/>
            </p:nvSpPr>
            <p:spPr>
              <a:xfrm>
                <a:off x="9072976" y="-945514"/>
                <a:ext cx="72000" cy="72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2138A1E1-6550-310D-4B7B-C62E46FFBF92}"/>
                  </a:ext>
                </a:extLst>
              </p:cNvPr>
              <p:cNvSpPr txBox="1"/>
              <p:nvPr/>
            </p:nvSpPr>
            <p:spPr>
              <a:xfrm>
                <a:off x="9103567" y="-1032624"/>
                <a:ext cx="9092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i="1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F. </a:t>
                </a:r>
                <a:r>
                  <a:rPr kumimoji="1" lang="en-US" altLang="ja-JP" sz="1000" i="1" dirty="0" err="1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prausnitzii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E777CF45-B257-DFF9-B6E8-A605CE6134B2}"/>
                  </a:ext>
                </a:extLst>
              </p:cNvPr>
              <p:cNvSpPr txBox="1"/>
              <p:nvPr/>
            </p:nvSpPr>
            <p:spPr>
              <a:xfrm>
                <a:off x="9103567" y="-736058"/>
                <a:ext cx="16241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i="1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F. </a:t>
                </a:r>
                <a:r>
                  <a:rPr kumimoji="1" lang="en-US" altLang="ja-JP" sz="1000" i="1" dirty="0" err="1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varium</a:t>
                </a:r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 + </a:t>
                </a:r>
                <a:r>
                  <a:rPr kumimoji="1" lang="en-US" altLang="ja-JP" sz="1000" i="1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F. </a:t>
                </a:r>
                <a:r>
                  <a:rPr kumimoji="1" lang="en-US" altLang="ja-JP" sz="1000" i="1" dirty="0" err="1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prausnitzii</a:t>
                </a:r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 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DE250309-4B97-421D-655C-3257006FA18B}"/>
                  </a:ext>
                </a:extLst>
              </p:cNvPr>
              <p:cNvSpPr txBox="1"/>
              <p:nvPr/>
            </p:nvSpPr>
            <p:spPr>
              <a:xfrm>
                <a:off x="9103567" y="-884341"/>
                <a:ext cx="7184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kumimoji="1" lang="en-US" altLang="ja-JP" sz="1000" i="1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F. </a:t>
                </a:r>
                <a:r>
                  <a:rPr kumimoji="1" lang="en-US" altLang="ja-JP" sz="1000" i="1" dirty="0" err="1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varium</a:t>
                </a:r>
                <a:endParaRPr kumimoji="1" lang="ja-JP" altLang="en-US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9" name="楕円 58">
                <a:extLst>
                  <a:ext uri="{FF2B5EF4-FFF2-40B4-BE49-F238E27FC236}">
                    <a16:creationId xmlns:a16="http://schemas.microsoft.com/office/drawing/2014/main" id="{79D2DDFD-0D5D-F5FD-1A98-CDCF1E07CEBE}"/>
                  </a:ext>
                </a:extLst>
              </p:cNvPr>
              <p:cNvSpPr/>
              <p:nvPr/>
            </p:nvSpPr>
            <p:spPr>
              <a:xfrm>
                <a:off x="9072976" y="-797231"/>
                <a:ext cx="72000" cy="72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B091E531-E334-6D6E-04E8-4CB5490A0E58}"/>
                </a:ext>
              </a:extLst>
            </p:cNvPr>
            <p:cNvSpPr/>
            <p:nvPr/>
          </p:nvSpPr>
          <p:spPr>
            <a:xfrm>
              <a:off x="9020636" y="-1032624"/>
              <a:ext cx="1663578" cy="5427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466533E-5872-7D33-066E-34F895C9A945}"/>
              </a:ext>
            </a:extLst>
          </p:cNvPr>
          <p:cNvSpPr txBox="1"/>
          <p:nvPr/>
        </p:nvSpPr>
        <p:spPr>
          <a:xfrm>
            <a:off x="2281236" y="4715073"/>
            <a:ext cx="47593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1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utyric acid concentration in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ultures.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 species alone or both together were cultured for 24 h. Butyric acid was measured by LC-MS/MS (n = 4, mean ± 1 SD).</a:t>
            </a:r>
            <a:endParaRPr lang="ja-JP" alt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83206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687FCCF-C980-5FC5-53BF-7831AC2858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5651" y="1896848"/>
            <a:ext cx="2286953" cy="1720215"/>
          </a:xfrm>
          <a:prstGeom prst="rect">
            <a:avLst/>
          </a:prstGeom>
        </p:spPr>
      </p:pic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278718A4-C01D-5C44-A96A-CBDB7991778D}"/>
              </a:ext>
            </a:extLst>
          </p:cNvPr>
          <p:cNvGrpSpPr/>
          <p:nvPr/>
        </p:nvGrpSpPr>
        <p:grpSpPr>
          <a:xfrm>
            <a:off x="3632561" y="3448753"/>
            <a:ext cx="576000" cy="346553"/>
            <a:chOff x="3626166" y="2311388"/>
            <a:chExt cx="576000" cy="346553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047E81B-1AC8-7D06-C95B-A9F6D2019F7F}"/>
                </a:ext>
              </a:extLst>
            </p:cNvPr>
            <p:cNvSpPr txBox="1"/>
            <p:nvPr/>
          </p:nvSpPr>
          <p:spPr>
            <a:xfrm>
              <a:off x="3729660" y="2411720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0 h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86DC1CAA-946C-33F5-D5E4-0498050C8CB6}"/>
                </a:ext>
              </a:extLst>
            </p:cNvPr>
            <p:cNvCxnSpPr>
              <a:cxnSpLocks/>
            </p:cNvCxnSpPr>
            <p:nvPr/>
          </p:nvCxnSpPr>
          <p:spPr>
            <a:xfrm>
              <a:off x="3626166" y="2442858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直角三角形 7">
              <a:extLst>
                <a:ext uri="{FF2B5EF4-FFF2-40B4-BE49-F238E27FC236}">
                  <a16:creationId xmlns:a16="http://schemas.microsoft.com/office/drawing/2014/main" id="{564176E4-B03A-12A8-3CEC-1452C59C5CD4}"/>
                </a:ext>
              </a:extLst>
            </p:cNvPr>
            <p:cNvSpPr/>
            <p:nvPr/>
          </p:nvSpPr>
          <p:spPr>
            <a:xfrm flipH="1">
              <a:off x="3792775" y="2311388"/>
              <a:ext cx="401831" cy="114300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34446BDE-01D1-4425-467B-7E9D73B39F38}"/>
              </a:ext>
            </a:extLst>
          </p:cNvPr>
          <p:cNvGrpSpPr/>
          <p:nvPr/>
        </p:nvGrpSpPr>
        <p:grpSpPr>
          <a:xfrm>
            <a:off x="3003615" y="1952554"/>
            <a:ext cx="585103" cy="1528263"/>
            <a:chOff x="751019" y="815189"/>
            <a:chExt cx="585103" cy="1528263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31343B6-3B2C-B0E8-4D12-D5AAD5684A1A}"/>
                </a:ext>
              </a:extLst>
            </p:cNvPr>
            <p:cNvSpPr txBox="1"/>
            <p:nvPr/>
          </p:nvSpPr>
          <p:spPr>
            <a:xfrm rot="16200000">
              <a:off x="413908" y="1376446"/>
              <a:ext cx="107433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varium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(×10</a:t>
              </a:r>
              <a:r>
                <a:rPr kumimoji="1" lang="en-US" altLang="ja-JP" sz="1000" baseline="30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9</a:t>
              </a:r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 cells/ml)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E29EDCFA-922F-A405-456F-DD9B95B70356}"/>
                </a:ext>
              </a:extLst>
            </p:cNvPr>
            <p:cNvSpPr txBox="1"/>
            <p:nvPr/>
          </p:nvSpPr>
          <p:spPr>
            <a:xfrm>
              <a:off x="1080924" y="209723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6C6E7C3F-5D18-621D-5F45-6C02E76445DA}"/>
                </a:ext>
              </a:extLst>
            </p:cNvPr>
            <p:cNvSpPr txBox="1"/>
            <p:nvPr/>
          </p:nvSpPr>
          <p:spPr>
            <a:xfrm>
              <a:off x="1080924" y="177671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2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34CFE5E-9176-603C-91FD-67A3E954B30A}"/>
                </a:ext>
              </a:extLst>
            </p:cNvPr>
            <p:cNvSpPr txBox="1"/>
            <p:nvPr/>
          </p:nvSpPr>
          <p:spPr>
            <a:xfrm>
              <a:off x="1080924" y="145620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4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EACAC70A-D3EA-D742-2D34-E32BAAAE1B76}"/>
                </a:ext>
              </a:extLst>
            </p:cNvPr>
            <p:cNvSpPr txBox="1"/>
            <p:nvPr/>
          </p:nvSpPr>
          <p:spPr>
            <a:xfrm>
              <a:off x="1080924" y="113569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6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CCBA21B-0735-F7FC-9576-099229CC1B7E}"/>
                </a:ext>
              </a:extLst>
            </p:cNvPr>
            <p:cNvSpPr txBox="1"/>
            <p:nvPr/>
          </p:nvSpPr>
          <p:spPr>
            <a:xfrm>
              <a:off x="1080924" y="81518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8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CF409A7C-F7A9-1212-FA34-BD72AC604C86}"/>
              </a:ext>
            </a:extLst>
          </p:cNvPr>
          <p:cNvGrpSpPr/>
          <p:nvPr/>
        </p:nvGrpSpPr>
        <p:grpSpPr>
          <a:xfrm>
            <a:off x="4255132" y="3448753"/>
            <a:ext cx="576000" cy="346553"/>
            <a:chOff x="3626166" y="2311388"/>
            <a:chExt cx="576000" cy="346553"/>
          </a:xfrm>
        </p:grpSpPr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2AAB935-4C11-9D26-D728-98B257D62D9E}"/>
                </a:ext>
              </a:extLst>
            </p:cNvPr>
            <p:cNvSpPr txBox="1"/>
            <p:nvPr/>
          </p:nvSpPr>
          <p:spPr>
            <a:xfrm>
              <a:off x="3698402" y="2411720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24 h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F61AF6ED-CBE8-426F-7E8B-333B9BA82037}"/>
                </a:ext>
              </a:extLst>
            </p:cNvPr>
            <p:cNvCxnSpPr>
              <a:cxnSpLocks/>
            </p:cNvCxnSpPr>
            <p:nvPr/>
          </p:nvCxnSpPr>
          <p:spPr>
            <a:xfrm>
              <a:off x="3626166" y="2442858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直角三角形 18">
              <a:extLst>
                <a:ext uri="{FF2B5EF4-FFF2-40B4-BE49-F238E27FC236}">
                  <a16:creationId xmlns:a16="http://schemas.microsoft.com/office/drawing/2014/main" id="{6515EF69-DB85-951D-AB4E-A8B0890E8621}"/>
                </a:ext>
              </a:extLst>
            </p:cNvPr>
            <p:cNvSpPr/>
            <p:nvPr/>
          </p:nvSpPr>
          <p:spPr>
            <a:xfrm flipH="1">
              <a:off x="3792775" y="2311388"/>
              <a:ext cx="401831" cy="114300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45EB3B2C-8B2E-B39E-532F-6046D9948CA4}"/>
              </a:ext>
            </a:extLst>
          </p:cNvPr>
          <p:cNvGrpSpPr/>
          <p:nvPr/>
        </p:nvGrpSpPr>
        <p:grpSpPr>
          <a:xfrm>
            <a:off x="4877702" y="3448753"/>
            <a:ext cx="576000" cy="346553"/>
            <a:chOff x="3626166" y="2311388"/>
            <a:chExt cx="576000" cy="346553"/>
          </a:xfrm>
        </p:grpSpPr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ECAD812C-9FBB-78F7-FB3A-848FD32F7B28}"/>
                </a:ext>
              </a:extLst>
            </p:cNvPr>
            <p:cNvSpPr txBox="1"/>
            <p:nvPr/>
          </p:nvSpPr>
          <p:spPr>
            <a:xfrm>
              <a:off x="3698402" y="2411720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48 h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909AFCD4-AE43-8772-5615-5743F3666025}"/>
                </a:ext>
              </a:extLst>
            </p:cNvPr>
            <p:cNvCxnSpPr>
              <a:cxnSpLocks/>
            </p:cNvCxnSpPr>
            <p:nvPr/>
          </p:nvCxnSpPr>
          <p:spPr>
            <a:xfrm>
              <a:off x="3626166" y="2442858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直角三角形 22">
              <a:extLst>
                <a:ext uri="{FF2B5EF4-FFF2-40B4-BE49-F238E27FC236}">
                  <a16:creationId xmlns:a16="http://schemas.microsoft.com/office/drawing/2014/main" id="{FE8070ED-D8CB-871D-4028-A42E26990F90}"/>
                </a:ext>
              </a:extLst>
            </p:cNvPr>
            <p:cNvSpPr/>
            <p:nvPr/>
          </p:nvSpPr>
          <p:spPr>
            <a:xfrm flipH="1">
              <a:off x="3792775" y="2311388"/>
              <a:ext cx="401831" cy="114300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F18EAE33-8777-8E7F-B2B9-E71203F3817F}"/>
              </a:ext>
            </a:extLst>
          </p:cNvPr>
          <p:cNvGrpSpPr/>
          <p:nvPr/>
        </p:nvGrpSpPr>
        <p:grpSpPr>
          <a:xfrm>
            <a:off x="3747701" y="3887976"/>
            <a:ext cx="1769465" cy="394504"/>
            <a:chOff x="7113603" y="2782552"/>
            <a:chExt cx="2146683" cy="394504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2131CC65-CB3B-832D-99D4-636DB16996DD}"/>
                </a:ext>
              </a:extLst>
            </p:cNvPr>
            <p:cNvSpPr/>
            <p:nvPr/>
          </p:nvSpPr>
          <p:spPr>
            <a:xfrm>
              <a:off x="7167649" y="2869662"/>
              <a:ext cx="72000" cy="72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5B8AAF39-0DA7-89E4-6D02-3FF2BE3BCA2C}"/>
                </a:ext>
              </a:extLst>
            </p:cNvPr>
            <p:cNvSpPr/>
            <p:nvPr/>
          </p:nvSpPr>
          <p:spPr>
            <a:xfrm>
              <a:off x="7167649" y="3017945"/>
              <a:ext cx="72000" cy="72000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A9FDFFE7-52F7-58A2-5DE3-C6AD643E11D1}"/>
                </a:ext>
              </a:extLst>
            </p:cNvPr>
            <p:cNvSpPr txBox="1"/>
            <p:nvPr/>
          </p:nvSpPr>
          <p:spPr>
            <a:xfrm>
              <a:off x="7196534" y="2782552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YCFA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1915A5B-F3A2-3C2A-D4BE-8CCA19ECC6DF}"/>
                </a:ext>
              </a:extLst>
            </p:cNvPr>
            <p:cNvSpPr txBox="1"/>
            <p:nvPr/>
          </p:nvSpPr>
          <p:spPr>
            <a:xfrm>
              <a:off x="7196534" y="2930835"/>
              <a:ext cx="20637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+ Sup. at 12.5, 25, or 50%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58F11A60-D97B-C518-A8C8-E87C1050A61E}"/>
                </a:ext>
              </a:extLst>
            </p:cNvPr>
            <p:cNvSpPr/>
            <p:nvPr/>
          </p:nvSpPr>
          <p:spPr>
            <a:xfrm>
              <a:off x="7113603" y="2782553"/>
              <a:ext cx="2020968" cy="3793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30A43CC-7F7A-BEFB-12E7-02EFDAD25805}"/>
              </a:ext>
            </a:extLst>
          </p:cNvPr>
          <p:cNvSpPr txBox="1"/>
          <p:nvPr/>
        </p:nvSpPr>
        <p:spPr>
          <a:xfrm>
            <a:off x="4624303" y="2662485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**</a:t>
            </a:r>
            <a:endParaRPr kumimoji="1" lang="ja-JP" altLang="en-US" sz="12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6852114-13AF-BDA5-445B-053111FD3D4F}"/>
              </a:ext>
            </a:extLst>
          </p:cNvPr>
          <p:cNvSpPr txBox="1"/>
          <p:nvPr/>
        </p:nvSpPr>
        <p:spPr>
          <a:xfrm>
            <a:off x="6708483" y="15240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pplementary Figure 2</a:t>
            </a:r>
            <a:endParaRPr kumimoji="1" lang="ja-JP" altLang="en-US" sz="14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4A54E46-95FC-7AC8-2ACF-E69B267ED05A}"/>
              </a:ext>
            </a:extLst>
          </p:cNvPr>
          <p:cNvSpPr txBox="1"/>
          <p:nvPr/>
        </p:nvSpPr>
        <p:spPr>
          <a:xfrm>
            <a:off x="2243136" y="4715073"/>
            <a:ext cx="475932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2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ffect of supernatant from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ulture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rowth.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usobacterium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as cultured in the absence or presence of the supernatant from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ulture at a concentration of 12.5%, 25%, or 50%. The number of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lls was measured by quantitative PCR (n = 4, mean ± 1 SD). **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&lt; 0.01 (one-way ANOVA).</a:t>
            </a:r>
            <a:endParaRPr lang="ja-JP" alt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0851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FBABA1B-B76F-0AF6-C4C1-F7FA956E35E1}"/>
              </a:ext>
            </a:extLst>
          </p:cNvPr>
          <p:cNvSpPr txBox="1"/>
          <p:nvPr/>
        </p:nvSpPr>
        <p:spPr>
          <a:xfrm>
            <a:off x="6708483" y="15240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pplementary Figure 3</a:t>
            </a:r>
            <a:endParaRPr kumimoji="1" lang="ja-JP" altLang="en-US" sz="14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BA41752-6635-9F4D-803B-7FA8FDFB945E}"/>
              </a:ext>
            </a:extLst>
          </p:cNvPr>
          <p:cNvSpPr txBox="1"/>
          <p:nvPr/>
        </p:nvSpPr>
        <p:spPr>
          <a:xfrm>
            <a:off x="3847284" y="1506211"/>
            <a:ext cx="12795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UniWells</a:t>
            </a:r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 horizontal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co-culture plate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6999C399-86F7-C786-DEBE-476B34E7F577}"/>
              </a:ext>
            </a:extLst>
          </p:cNvPr>
          <p:cNvGrpSpPr/>
          <p:nvPr/>
        </p:nvGrpSpPr>
        <p:grpSpPr>
          <a:xfrm>
            <a:off x="3752712" y="1870233"/>
            <a:ext cx="1505883" cy="844999"/>
            <a:chOff x="674188" y="875351"/>
            <a:chExt cx="1505883" cy="844999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D8DC904-BCD0-2CBB-682F-E836F52A7F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5726" b="33146"/>
            <a:stretch/>
          </p:blipFill>
          <p:spPr>
            <a:xfrm>
              <a:off x="674188" y="875351"/>
              <a:ext cx="1505883" cy="844999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0F5EEA4-2261-90E1-889D-17912898159B}"/>
                </a:ext>
              </a:extLst>
            </p:cNvPr>
            <p:cNvSpPr txBox="1"/>
            <p:nvPr/>
          </p:nvSpPr>
          <p:spPr>
            <a:xfrm>
              <a:off x="897622" y="1297850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BFC45CBD-0192-32F0-87D2-22053DB0CFB2}"/>
                </a:ext>
              </a:extLst>
            </p:cNvPr>
            <p:cNvSpPr txBox="1"/>
            <p:nvPr/>
          </p:nvSpPr>
          <p:spPr>
            <a:xfrm>
              <a:off x="1679161" y="1297850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52714A7-64CF-4320-2EE6-19401939796B}"/>
              </a:ext>
            </a:extLst>
          </p:cNvPr>
          <p:cNvSpPr txBox="1"/>
          <p:nvPr/>
        </p:nvSpPr>
        <p:spPr>
          <a:xfrm>
            <a:off x="4088517" y="2070956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Main body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C7A4166-4FAF-E2AA-B06C-F62ECE099D4B}"/>
              </a:ext>
            </a:extLst>
          </p:cNvPr>
          <p:cNvSpPr txBox="1"/>
          <p:nvPr/>
        </p:nvSpPr>
        <p:spPr>
          <a:xfrm>
            <a:off x="3742474" y="2739109"/>
            <a:ext cx="16754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Connection (close or filter)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EC5CF019-8AA3-CB62-EF59-9BAEDF82A70D}"/>
              </a:ext>
            </a:extLst>
          </p:cNvPr>
          <p:cNvCxnSpPr>
            <a:cxnSpLocks/>
          </p:cNvCxnSpPr>
          <p:nvPr/>
        </p:nvCxnSpPr>
        <p:spPr>
          <a:xfrm flipV="1">
            <a:off x="4232969" y="2317177"/>
            <a:ext cx="238715" cy="45801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A3DC1ACD-950F-8ACC-C361-18A227BEE4D0}"/>
              </a:ext>
            </a:extLst>
          </p:cNvPr>
          <p:cNvGrpSpPr/>
          <p:nvPr/>
        </p:nvGrpSpPr>
        <p:grpSpPr>
          <a:xfrm>
            <a:off x="3631141" y="3449548"/>
            <a:ext cx="4822215" cy="1054776"/>
            <a:chOff x="2107141" y="3729518"/>
            <a:chExt cx="4822215" cy="1054776"/>
          </a:xfrm>
        </p:grpSpPr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9FF48860-D96B-3FD2-82C2-797BDBF3FDFC}"/>
                </a:ext>
              </a:extLst>
            </p:cNvPr>
            <p:cNvSpPr txBox="1"/>
            <p:nvPr/>
          </p:nvSpPr>
          <p:spPr>
            <a:xfrm>
              <a:off x="2337915" y="3983239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Closed</a:t>
              </a: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526B3C68-B822-F108-8FF1-8F7D9E52A475}"/>
                </a:ext>
              </a:extLst>
            </p:cNvPr>
            <p:cNvSpPr txBox="1"/>
            <p:nvPr/>
          </p:nvSpPr>
          <p:spPr>
            <a:xfrm>
              <a:off x="3690199" y="3983239"/>
              <a:ext cx="909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prausnitzii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BA0F4FF6-D029-137D-2077-C26AB524FFA2}"/>
                </a:ext>
              </a:extLst>
            </p:cNvPr>
            <p:cNvSpPr txBox="1"/>
            <p:nvPr/>
          </p:nvSpPr>
          <p:spPr>
            <a:xfrm>
              <a:off x="2337915" y="4164003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Closed</a:t>
              </a: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C6073D07-8ADB-04D1-B10B-892691134837}"/>
                </a:ext>
              </a:extLst>
            </p:cNvPr>
            <p:cNvSpPr txBox="1"/>
            <p:nvPr/>
          </p:nvSpPr>
          <p:spPr>
            <a:xfrm>
              <a:off x="3690199" y="4164003"/>
              <a:ext cx="15888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prausnitzii</a:t>
              </a:r>
              <a:r>
                <a:rPr kumimoji="1" lang="ja-JP" altLang="en-US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+ </a:t>
              </a:r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varium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D694802B-E7C2-CA9A-271F-A8A5C6272A0B}"/>
                </a:ext>
              </a:extLst>
            </p:cNvPr>
            <p:cNvSpPr txBox="1"/>
            <p:nvPr/>
          </p:nvSpPr>
          <p:spPr>
            <a:xfrm>
              <a:off x="2337915" y="4344767"/>
              <a:ext cx="10550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ilter (0.03 </a:t>
              </a:r>
              <a:r>
                <a:rPr kumimoji="1" lang="el-GR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μ</a:t>
              </a:r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D8D85CD-3F59-4158-9CD4-DD63E42F3C89}"/>
                </a:ext>
              </a:extLst>
            </p:cNvPr>
            <p:cNvSpPr txBox="1"/>
            <p:nvPr/>
          </p:nvSpPr>
          <p:spPr>
            <a:xfrm>
              <a:off x="3690199" y="4344767"/>
              <a:ext cx="909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prausnitzii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B52E14D7-CF55-4B7B-9CE5-1E7C0AFD10E9}"/>
                </a:ext>
              </a:extLst>
            </p:cNvPr>
            <p:cNvSpPr txBox="1"/>
            <p:nvPr/>
          </p:nvSpPr>
          <p:spPr>
            <a:xfrm>
              <a:off x="2337915" y="4525532"/>
              <a:ext cx="984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ilter (0.6 </a:t>
              </a:r>
              <a:r>
                <a:rPr kumimoji="1" lang="el-GR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μ</a:t>
              </a:r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4DD4D3A9-52FA-E971-DBB3-E1C9C9A53A37}"/>
                </a:ext>
              </a:extLst>
            </p:cNvPr>
            <p:cNvSpPr txBox="1"/>
            <p:nvPr/>
          </p:nvSpPr>
          <p:spPr>
            <a:xfrm>
              <a:off x="3690199" y="4525532"/>
              <a:ext cx="909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prausnitzii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141774DA-90A1-01A3-FFB4-C65DD27E4332}"/>
                </a:ext>
              </a:extLst>
            </p:cNvPr>
            <p:cNvSpPr txBox="1"/>
            <p:nvPr/>
          </p:nvSpPr>
          <p:spPr>
            <a:xfrm>
              <a:off x="5566482" y="3983239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Empty</a:t>
              </a: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5D1F7A9B-155F-9BD2-D14D-D247229196CE}"/>
                </a:ext>
              </a:extLst>
            </p:cNvPr>
            <p:cNvSpPr txBox="1"/>
            <p:nvPr/>
          </p:nvSpPr>
          <p:spPr>
            <a:xfrm>
              <a:off x="5566482" y="4164003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Empty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479D36EC-8ED1-1F0C-6399-509748BECCB1}"/>
                </a:ext>
              </a:extLst>
            </p:cNvPr>
            <p:cNvSpPr txBox="1"/>
            <p:nvPr/>
          </p:nvSpPr>
          <p:spPr>
            <a:xfrm>
              <a:off x="5566482" y="4344767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varium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9279A0F-07BC-AD73-14C9-580389B095B5}"/>
                </a:ext>
              </a:extLst>
            </p:cNvPr>
            <p:cNvSpPr txBox="1"/>
            <p:nvPr/>
          </p:nvSpPr>
          <p:spPr>
            <a:xfrm>
              <a:off x="5566482" y="4525532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F. </a:t>
              </a:r>
              <a:r>
                <a:rPr kumimoji="1" lang="en-US" altLang="ja-JP" sz="1000" i="1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varium</a:t>
              </a:r>
              <a:endPara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327FA139-79ED-E094-0921-54ADDA19F344}"/>
                </a:ext>
              </a:extLst>
            </p:cNvPr>
            <p:cNvSpPr txBox="1"/>
            <p:nvPr/>
          </p:nvSpPr>
          <p:spPr>
            <a:xfrm>
              <a:off x="2337915" y="3738555"/>
              <a:ext cx="8290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Connection</a:t>
              </a: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86759146-268C-8F67-0320-E7983F5A612F}"/>
                </a:ext>
              </a:extLst>
            </p:cNvPr>
            <p:cNvSpPr txBox="1"/>
            <p:nvPr/>
          </p:nvSpPr>
          <p:spPr>
            <a:xfrm>
              <a:off x="3690199" y="3738555"/>
              <a:ext cx="13628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Main body A (1.5 ml)</a:t>
              </a: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CCDB9C67-C0E0-E654-AF25-7F3665975350}"/>
                </a:ext>
              </a:extLst>
            </p:cNvPr>
            <p:cNvSpPr txBox="1"/>
            <p:nvPr/>
          </p:nvSpPr>
          <p:spPr>
            <a:xfrm>
              <a:off x="5566482" y="3738555"/>
              <a:ext cx="13628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Main body B (1.5 ml)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D929B928-E52C-7690-7BA0-126668B9CD77}"/>
                </a:ext>
              </a:extLst>
            </p:cNvPr>
            <p:cNvSpPr txBox="1"/>
            <p:nvPr/>
          </p:nvSpPr>
          <p:spPr>
            <a:xfrm>
              <a:off x="2107141" y="398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1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066BE788-6F89-4404-BDC8-49BA4A745843}"/>
                </a:ext>
              </a:extLst>
            </p:cNvPr>
            <p:cNvSpPr txBox="1"/>
            <p:nvPr/>
          </p:nvSpPr>
          <p:spPr>
            <a:xfrm>
              <a:off x="2107141" y="4164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2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A57338DA-286E-DDFC-6B53-284340D9F2BB}"/>
                </a:ext>
              </a:extLst>
            </p:cNvPr>
            <p:cNvSpPr txBox="1"/>
            <p:nvPr/>
          </p:nvSpPr>
          <p:spPr>
            <a:xfrm>
              <a:off x="2107141" y="434476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3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F7BEDBB9-57D2-D8A2-72A0-BCDF8A16C41E}"/>
                </a:ext>
              </a:extLst>
            </p:cNvPr>
            <p:cNvSpPr txBox="1"/>
            <p:nvPr/>
          </p:nvSpPr>
          <p:spPr>
            <a:xfrm>
              <a:off x="2107141" y="452553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4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B6ECDFF0-F36F-BD3C-5F37-17D0807444AC}"/>
                </a:ext>
              </a:extLst>
            </p:cNvPr>
            <p:cNvCxnSpPr>
              <a:cxnSpLocks/>
            </p:cNvCxnSpPr>
            <p:nvPr/>
          </p:nvCxnSpPr>
          <p:spPr>
            <a:xfrm>
              <a:off x="2120272" y="3974850"/>
              <a:ext cx="47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E353EF97-A635-262C-D501-319C6F067C74}"/>
                </a:ext>
              </a:extLst>
            </p:cNvPr>
            <p:cNvCxnSpPr>
              <a:cxnSpLocks/>
            </p:cNvCxnSpPr>
            <p:nvPr/>
          </p:nvCxnSpPr>
          <p:spPr>
            <a:xfrm>
              <a:off x="2120272" y="3729518"/>
              <a:ext cx="47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FC7027C4-15EF-4F87-2473-6BAED50FBD84}"/>
                </a:ext>
              </a:extLst>
            </p:cNvPr>
            <p:cNvCxnSpPr>
              <a:cxnSpLocks/>
            </p:cNvCxnSpPr>
            <p:nvPr/>
          </p:nvCxnSpPr>
          <p:spPr>
            <a:xfrm>
              <a:off x="2120272" y="4784294"/>
              <a:ext cx="47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0" name="図 59">
            <a:extLst>
              <a:ext uri="{FF2B5EF4-FFF2-40B4-BE49-F238E27FC236}">
                <a16:creationId xmlns:a16="http://schemas.microsoft.com/office/drawing/2014/main" id="{DDD59D4F-57A0-4210-C2EE-C1AD8F6E4D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4917" y="1269551"/>
            <a:ext cx="2286953" cy="1773555"/>
          </a:xfrm>
          <a:prstGeom prst="rect">
            <a:avLst/>
          </a:prstGeom>
        </p:spPr>
      </p:pic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365EF0E-73B7-C629-2142-439004565A64}"/>
              </a:ext>
            </a:extLst>
          </p:cNvPr>
          <p:cNvSpPr txBox="1"/>
          <p:nvPr/>
        </p:nvSpPr>
        <p:spPr>
          <a:xfrm rot="16200000">
            <a:off x="5421948" y="1883699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. </a:t>
            </a:r>
            <a:r>
              <a:rPr kumimoji="1" lang="en-US" altLang="ja-JP" sz="1000" i="1" dirty="0" err="1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prausnitzii</a:t>
            </a:r>
            <a:endParaRPr kumimoji="1" lang="en-US" altLang="ja-JP" sz="1000" i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(×10</a:t>
            </a:r>
            <a:r>
              <a:rPr kumimoji="1" lang="en-US" altLang="ja-JP" sz="1000" baseline="30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9</a:t>
            </a:r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 cells/ml)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60421A9D-5701-AD69-DD01-8CDEF2493012}"/>
              </a:ext>
            </a:extLst>
          </p:cNvPr>
          <p:cNvSpPr txBox="1"/>
          <p:nvPr/>
        </p:nvSpPr>
        <p:spPr>
          <a:xfrm>
            <a:off x="6095375" y="260448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F9AF297-5690-4EAD-5133-16DD6261FD90}"/>
              </a:ext>
            </a:extLst>
          </p:cNvPr>
          <p:cNvSpPr txBox="1"/>
          <p:nvPr/>
        </p:nvSpPr>
        <p:spPr>
          <a:xfrm>
            <a:off x="6095374" y="2348074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F20E05C-FA60-8505-B56C-04CEDF96F4C3}"/>
              </a:ext>
            </a:extLst>
          </p:cNvPr>
          <p:cNvSpPr txBox="1"/>
          <p:nvPr/>
        </p:nvSpPr>
        <p:spPr>
          <a:xfrm>
            <a:off x="6095374" y="209166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BC309A87-BCBE-47BE-E711-1DC7C605E0CD}"/>
              </a:ext>
            </a:extLst>
          </p:cNvPr>
          <p:cNvSpPr txBox="1"/>
          <p:nvPr/>
        </p:nvSpPr>
        <p:spPr>
          <a:xfrm>
            <a:off x="6095374" y="1835258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3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6803733-DFDB-1C05-B98D-E35FBBE204A0}"/>
              </a:ext>
            </a:extLst>
          </p:cNvPr>
          <p:cNvSpPr txBox="1"/>
          <p:nvPr/>
        </p:nvSpPr>
        <p:spPr>
          <a:xfrm>
            <a:off x="6095375" y="13224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5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E40E27C-EA16-A832-BFDF-FBD4AC17BB5B}"/>
              </a:ext>
            </a:extLst>
          </p:cNvPr>
          <p:cNvSpPr txBox="1"/>
          <p:nvPr/>
        </p:nvSpPr>
        <p:spPr>
          <a:xfrm>
            <a:off x="6095374" y="157885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CD28AF8E-7338-BD72-9CE4-614057F32ABE}"/>
              </a:ext>
            </a:extLst>
          </p:cNvPr>
          <p:cNvGrpSpPr/>
          <p:nvPr/>
        </p:nvGrpSpPr>
        <p:grpSpPr>
          <a:xfrm>
            <a:off x="6408704" y="2921980"/>
            <a:ext cx="864000" cy="246221"/>
            <a:chOff x="3384349" y="1931369"/>
            <a:chExt cx="864000" cy="246221"/>
          </a:xfrm>
        </p:grpSpPr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F1F8A704-2D83-1525-F4D2-CB14CD6601F3}"/>
                </a:ext>
              </a:extLst>
            </p:cNvPr>
            <p:cNvSpPr txBox="1"/>
            <p:nvPr/>
          </p:nvSpPr>
          <p:spPr>
            <a:xfrm>
              <a:off x="3600585" y="1931369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24 h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A5B03309-74D5-0305-7D29-49825E940B55}"/>
                </a:ext>
              </a:extLst>
            </p:cNvPr>
            <p:cNvCxnSpPr>
              <a:cxnSpLocks/>
            </p:cNvCxnSpPr>
            <p:nvPr/>
          </p:nvCxnSpPr>
          <p:spPr>
            <a:xfrm>
              <a:off x="3384349" y="1962507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3A356027-DB66-02F3-F9E9-0359E26834F6}"/>
              </a:ext>
            </a:extLst>
          </p:cNvPr>
          <p:cNvGrpSpPr/>
          <p:nvPr/>
        </p:nvGrpSpPr>
        <p:grpSpPr>
          <a:xfrm>
            <a:off x="7335280" y="2921980"/>
            <a:ext cx="864000" cy="246221"/>
            <a:chOff x="4451419" y="1931369"/>
            <a:chExt cx="864000" cy="246221"/>
          </a:xfrm>
        </p:grpSpPr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A1FA06DC-E3FD-F1DE-DFDD-523F578871F9}"/>
                </a:ext>
              </a:extLst>
            </p:cNvPr>
            <p:cNvSpPr txBox="1"/>
            <p:nvPr/>
          </p:nvSpPr>
          <p:spPr>
            <a:xfrm>
              <a:off x="4667655" y="1931369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48 h</a:t>
              </a:r>
              <a:endParaRPr kumimoji="1" lang="ja-JP" altLang="en-US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C5513263-B7FC-BB63-68D1-1A23D0C0DD61}"/>
                </a:ext>
              </a:extLst>
            </p:cNvPr>
            <p:cNvCxnSpPr>
              <a:cxnSpLocks/>
            </p:cNvCxnSpPr>
            <p:nvPr/>
          </p:nvCxnSpPr>
          <p:spPr>
            <a:xfrm>
              <a:off x="4451419" y="1962507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FCA5A766-F9B6-DFFA-CDC9-ECAC427086C6}"/>
              </a:ext>
            </a:extLst>
          </p:cNvPr>
          <p:cNvSpPr txBox="1"/>
          <p:nvPr/>
        </p:nvSpPr>
        <p:spPr>
          <a:xfrm>
            <a:off x="6366567" y="27307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C7B4ECF-6EF6-7B70-86AE-92AB19408573}"/>
              </a:ext>
            </a:extLst>
          </p:cNvPr>
          <p:cNvSpPr txBox="1"/>
          <p:nvPr/>
        </p:nvSpPr>
        <p:spPr>
          <a:xfrm>
            <a:off x="6597819" y="2730769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2E3E2B1E-191A-8431-C5A3-001F9AFA296D}"/>
              </a:ext>
            </a:extLst>
          </p:cNvPr>
          <p:cNvSpPr txBox="1"/>
          <p:nvPr/>
        </p:nvSpPr>
        <p:spPr>
          <a:xfrm>
            <a:off x="6829072" y="2730769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3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92BE7CA-E237-E5CE-6930-9D328208B44C}"/>
              </a:ext>
            </a:extLst>
          </p:cNvPr>
          <p:cNvSpPr txBox="1"/>
          <p:nvPr/>
        </p:nvSpPr>
        <p:spPr>
          <a:xfrm>
            <a:off x="7060325" y="2730769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885FEF2-67DE-5B9B-84E6-090FDDB8DD59}"/>
              </a:ext>
            </a:extLst>
          </p:cNvPr>
          <p:cNvSpPr txBox="1"/>
          <p:nvPr/>
        </p:nvSpPr>
        <p:spPr>
          <a:xfrm>
            <a:off x="7286448" y="27307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7FB24E6-7A6E-38EF-C249-A46F76EBAB4C}"/>
              </a:ext>
            </a:extLst>
          </p:cNvPr>
          <p:cNvSpPr txBox="1"/>
          <p:nvPr/>
        </p:nvSpPr>
        <p:spPr>
          <a:xfrm>
            <a:off x="7517700" y="2730769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3F3F7439-6F60-CFB2-4A5F-8C990118463C}"/>
              </a:ext>
            </a:extLst>
          </p:cNvPr>
          <p:cNvSpPr txBox="1"/>
          <p:nvPr/>
        </p:nvSpPr>
        <p:spPr>
          <a:xfrm>
            <a:off x="7748953" y="2730769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3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6D96A861-FF53-CA8E-2477-0BF3F111FCFE}"/>
              </a:ext>
            </a:extLst>
          </p:cNvPr>
          <p:cNvSpPr txBox="1"/>
          <p:nvPr/>
        </p:nvSpPr>
        <p:spPr>
          <a:xfrm>
            <a:off x="7980206" y="2730769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1000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C3BE4C46-74B1-AB22-3641-E98DAE0C379D}"/>
              </a:ext>
            </a:extLst>
          </p:cNvPr>
          <p:cNvGrpSpPr/>
          <p:nvPr/>
        </p:nvGrpSpPr>
        <p:grpSpPr>
          <a:xfrm>
            <a:off x="388273" y="1506211"/>
            <a:ext cx="2802348" cy="2251408"/>
            <a:chOff x="293490" y="3747858"/>
            <a:chExt cx="2802348" cy="2251408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244C1632-8395-05AA-B690-C540810E83F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5523" y="3747858"/>
              <a:ext cx="2520315" cy="1893570"/>
            </a:xfrm>
            <a:prstGeom prst="rect">
              <a:avLst/>
            </a:prstGeom>
          </p:spPr>
        </p:pic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BEF6D676-AFCA-8CEB-FC09-643786600C03}"/>
                </a:ext>
              </a:extLst>
            </p:cNvPr>
            <p:cNvGrpSpPr/>
            <p:nvPr/>
          </p:nvGrpSpPr>
          <p:grpSpPr>
            <a:xfrm>
              <a:off x="922433" y="5299763"/>
              <a:ext cx="576000" cy="346553"/>
              <a:chOff x="3626166" y="2311388"/>
              <a:chExt cx="576000" cy="346553"/>
            </a:xfrm>
          </p:grpSpPr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96CBABB2-0C3F-7584-2EE2-80CB9EC0BE5E}"/>
                  </a:ext>
                </a:extLst>
              </p:cNvPr>
              <p:cNvSpPr txBox="1"/>
              <p:nvPr/>
            </p:nvSpPr>
            <p:spPr>
              <a:xfrm>
                <a:off x="3729660" y="2411720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0 h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33D7E62A-C2ED-D110-7589-4650CF558C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26166" y="2442858"/>
                <a:ext cx="57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直角三角形 81">
                <a:extLst>
                  <a:ext uri="{FF2B5EF4-FFF2-40B4-BE49-F238E27FC236}">
                    <a16:creationId xmlns:a16="http://schemas.microsoft.com/office/drawing/2014/main" id="{2DE43BE6-167B-F363-9595-7E4152911E9C}"/>
                  </a:ext>
                </a:extLst>
              </p:cNvPr>
              <p:cNvSpPr/>
              <p:nvPr/>
            </p:nvSpPr>
            <p:spPr>
              <a:xfrm flipH="1">
                <a:off x="3792775" y="2311388"/>
                <a:ext cx="401831" cy="114300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/>
              </a:p>
            </p:txBody>
          </p:sp>
        </p:grp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05D36C80-CB7A-8032-4418-B53FF42E27EE}"/>
                </a:ext>
              </a:extLst>
            </p:cNvPr>
            <p:cNvGrpSpPr/>
            <p:nvPr/>
          </p:nvGrpSpPr>
          <p:grpSpPr>
            <a:xfrm>
              <a:off x="293490" y="3803564"/>
              <a:ext cx="585100" cy="1528263"/>
              <a:chOff x="293490" y="3803564"/>
              <a:chExt cx="585100" cy="1528263"/>
            </a:xfrm>
          </p:grpSpPr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6EBE5512-8588-5016-35FD-69E1CF704842}"/>
                  </a:ext>
                </a:extLst>
              </p:cNvPr>
              <p:cNvSpPr txBox="1"/>
              <p:nvPr/>
            </p:nvSpPr>
            <p:spPr>
              <a:xfrm rot="16200000">
                <a:off x="-50034" y="4364821"/>
                <a:ext cx="10871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i="1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F. </a:t>
                </a:r>
                <a:r>
                  <a:rPr kumimoji="1" lang="en-US" altLang="ja-JP" sz="1000" i="1" dirty="0" err="1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prausnitzii</a:t>
                </a:r>
                <a:endParaRPr kumimoji="1" lang="en-US" altLang="ja-JP" sz="1000" i="1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(×10</a:t>
                </a:r>
                <a:r>
                  <a:rPr kumimoji="1" lang="en-US" altLang="ja-JP" sz="1000" baseline="30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9</a:t>
                </a:r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 cells/ml)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1531C7FB-97AD-C888-6057-3F7F7AB63704}"/>
                  </a:ext>
                </a:extLst>
              </p:cNvPr>
              <p:cNvSpPr txBox="1"/>
              <p:nvPr/>
            </p:nvSpPr>
            <p:spPr>
              <a:xfrm>
                <a:off x="623392" y="508560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0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B33F16C2-9FDD-E4A0-B244-4D24690870EB}"/>
                  </a:ext>
                </a:extLst>
              </p:cNvPr>
              <p:cNvSpPr txBox="1"/>
              <p:nvPr/>
            </p:nvSpPr>
            <p:spPr>
              <a:xfrm>
                <a:off x="623391" y="4765094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1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B277D469-E879-E2FF-6E45-9541230477B1}"/>
                  </a:ext>
                </a:extLst>
              </p:cNvPr>
              <p:cNvSpPr txBox="1"/>
              <p:nvPr/>
            </p:nvSpPr>
            <p:spPr>
              <a:xfrm>
                <a:off x="623391" y="4444584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2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1C0C49F1-8D43-D7DC-54AB-AF74CBEA579F}"/>
                  </a:ext>
                </a:extLst>
              </p:cNvPr>
              <p:cNvSpPr txBox="1"/>
              <p:nvPr/>
            </p:nvSpPr>
            <p:spPr>
              <a:xfrm>
                <a:off x="623391" y="4124074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3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E57BA69F-C58A-B3E6-F757-3AB0AF243CE0}"/>
                  </a:ext>
                </a:extLst>
              </p:cNvPr>
              <p:cNvSpPr txBox="1"/>
              <p:nvPr/>
            </p:nvSpPr>
            <p:spPr>
              <a:xfrm>
                <a:off x="623391" y="3803564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4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F2DF7317-B335-BB9E-6A39-39CE4397352D}"/>
                </a:ext>
              </a:extLst>
            </p:cNvPr>
            <p:cNvGrpSpPr/>
            <p:nvPr/>
          </p:nvGrpSpPr>
          <p:grpSpPr>
            <a:xfrm>
              <a:off x="1545004" y="5299763"/>
              <a:ext cx="576000" cy="346553"/>
              <a:chOff x="3626166" y="2311388"/>
              <a:chExt cx="576000" cy="346553"/>
            </a:xfrm>
          </p:grpSpPr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9EB51DBA-0E72-CB5D-A5EE-DAE0084C788D}"/>
                  </a:ext>
                </a:extLst>
              </p:cNvPr>
              <p:cNvSpPr txBox="1"/>
              <p:nvPr/>
            </p:nvSpPr>
            <p:spPr>
              <a:xfrm>
                <a:off x="3698402" y="2411720"/>
                <a:ext cx="4315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24 h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C680F3DD-49C1-6614-EFF3-02635058CA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26166" y="2442858"/>
                <a:ext cx="57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直角三角形 23">
                <a:extLst>
                  <a:ext uri="{FF2B5EF4-FFF2-40B4-BE49-F238E27FC236}">
                    <a16:creationId xmlns:a16="http://schemas.microsoft.com/office/drawing/2014/main" id="{6C0F9712-00BE-7F68-1423-7ADE1C44ACF5}"/>
                  </a:ext>
                </a:extLst>
              </p:cNvPr>
              <p:cNvSpPr/>
              <p:nvPr/>
            </p:nvSpPr>
            <p:spPr>
              <a:xfrm flipH="1">
                <a:off x="3792775" y="2311388"/>
                <a:ext cx="401831" cy="114300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/>
              </a:p>
            </p:txBody>
          </p:sp>
        </p:grp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29E80ACA-B182-37F1-D44A-DDA60AC6EC05}"/>
                </a:ext>
              </a:extLst>
            </p:cNvPr>
            <p:cNvGrpSpPr/>
            <p:nvPr/>
          </p:nvGrpSpPr>
          <p:grpSpPr>
            <a:xfrm>
              <a:off x="2167574" y="5299763"/>
              <a:ext cx="576000" cy="346553"/>
              <a:chOff x="3626166" y="2311388"/>
              <a:chExt cx="576000" cy="346553"/>
            </a:xfrm>
          </p:grpSpPr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FFDF59CE-C11E-3A92-7BFA-4BA94C4689D9}"/>
                  </a:ext>
                </a:extLst>
              </p:cNvPr>
              <p:cNvSpPr txBox="1"/>
              <p:nvPr/>
            </p:nvSpPr>
            <p:spPr>
              <a:xfrm>
                <a:off x="3698402" y="2411720"/>
                <a:ext cx="4315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48 h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665DD23D-8FA6-1B81-6304-DA62E67018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26166" y="2442858"/>
                <a:ext cx="57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直角三角形 20">
                <a:extLst>
                  <a:ext uri="{FF2B5EF4-FFF2-40B4-BE49-F238E27FC236}">
                    <a16:creationId xmlns:a16="http://schemas.microsoft.com/office/drawing/2014/main" id="{3504E457-0FBD-BCE7-5651-5E7C2E914CC1}"/>
                  </a:ext>
                </a:extLst>
              </p:cNvPr>
              <p:cNvSpPr/>
              <p:nvPr/>
            </p:nvSpPr>
            <p:spPr>
              <a:xfrm flipH="1">
                <a:off x="3792775" y="2311388"/>
                <a:ext cx="401831" cy="114300"/>
              </a:xfrm>
              <a:prstGeom prst="rt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/>
              </a:p>
            </p:txBody>
          </p:sp>
        </p:grp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33D17ABB-DA56-45D5-18FA-DFC267C127D3}"/>
                </a:ext>
              </a:extLst>
            </p:cNvPr>
            <p:cNvGrpSpPr/>
            <p:nvPr/>
          </p:nvGrpSpPr>
          <p:grpSpPr>
            <a:xfrm>
              <a:off x="987240" y="5604762"/>
              <a:ext cx="1734199" cy="394504"/>
              <a:chOff x="7113603" y="2782552"/>
              <a:chExt cx="2103899" cy="394504"/>
            </a:xfrm>
          </p:grpSpPr>
          <p:sp>
            <p:nvSpPr>
              <p:cNvPr id="14" name="正方形/長方形 13">
                <a:extLst>
                  <a:ext uri="{FF2B5EF4-FFF2-40B4-BE49-F238E27FC236}">
                    <a16:creationId xmlns:a16="http://schemas.microsoft.com/office/drawing/2014/main" id="{82F5EC02-ACF5-407B-5A32-E7F5FD39F9B7}"/>
                  </a:ext>
                </a:extLst>
              </p:cNvPr>
              <p:cNvSpPr/>
              <p:nvPr/>
            </p:nvSpPr>
            <p:spPr>
              <a:xfrm>
                <a:off x="7167649" y="2869662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" name="正方形/長方形 14">
                <a:extLst>
                  <a:ext uri="{FF2B5EF4-FFF2-40B4-BE49-F238E27FC236}">
                    <a16:creationId xmlns:a16="http://schemas.microsoft.com/office/drawing/2014/main" id="{5A8ADC8A-3FA0-7B95-3E28-74246BCE9060}"/>
                  </a:ext>
                </a:extLst>
              </p:cNvPr>
              <p:cNvSpPr/>
              <p:nvPr/>
            </p:nvSpPr>
            <p:spPr>
              <a:xfrm>
                <a:off x="7167649" y="3017945"/>
                <a:ext cx="72000" cy="72000"/>
              </a:xfrm>
              <a:prstGeom prst="rect">
                <a:avLst/>
              </a:prstGeom>
              <a:solidFill>
                <a:srgbClr val="00B05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51B55D8B-23C5-DC81-B872-9D6833FECA23}"/>
                  </a:ext>
                </a:extLst>
              </p:cNvPr>
              <p:cNvSpPr txBox="1"/>
              <p:nvPr/>
            </p:nvSpPr>
            <p:spPr>
              <a:xfrm>
                <a:off x="7196534" y="2782552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YCFA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0FC2C8D9-6B48-50A5-EDD0-5A9CFDE9BF80}"/>
                  </a:ext>
                </a:extLst>
              </p:cNvPr>
              <p:cNvSpPr txBox="1"/>
              <p:nvPr/>
            </p:nvSpPr>
            <p:spPr>
              <a:xfrm>
                <a:off x="7196534" y="2930835"/>
                <a:ext cx="20209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ea typeface="HGPｺﾞｼｯｸE" panose="020B0900000000000000" pitchFamily="50" charset="-128"/>
                    <a:cs typeface="Arial" panose="020B0604020202020204" pitchFamily="34" charset="0"/>
                  </a:rPr>
                  <a:t>+ Sup. at 12.5, 25, or 50%</a:t>
                </a:r>
                <a:endParaRPr kumimoji="1" lang="ja-JP" altLang="en-US" sz="10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" name="正方形/長方形 17">
                <a:extLst>
                  <a:ext uri="{FF2B5EF4-FFF2-40B4-BE49-F238E27FC236}">
                    <a16:creationId xmlns:a16="http://schemas.microsoft.com/office/drawing/2014/main" id="{3A89CFEF-E27B-B382-ACE0-D032A00B1CA4}"/>
                  </a:ext>
                </a:extLst>
              </p:cNvPr>
              <p:cNvSpPr/>
              <p:nvPr/>
            </p:nvSpPr>
            <p:spPr>
              <a:xfrm>
                <a:off x="7113603" y="2782553"/>
                <a:ext cx="2020968" cy="37938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14B15AA4-5986-570C-2BD9-E48A1F9285CD}"/>
              </a:ext>
            </a:extLst>
          </p:cNvPr>
          <p:cNvSpPr txBox="1"/>
          <p:nvPr/>
        </p:nvSpPr>
        <p:spPr>
          <a:xfrm>
            <a:off x="354691" y="131171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B5303FA6-B060-9896-BD6A-5C3EBC806D04}"/>
              </a:ext>
            </a:extLst>
          </p:cNvPr>
          <p:cNvSpPr txBox="1"/>
          <p:nvPr/>
        </p:nvSpPr>
        <p:spPr>
          <a:xfrm>
            <a:off x="3353501" y="131171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815E7FD-0D8E-6F6B-10B7-D64BFE017D61}"/>
              </a:ext>
            </a:extLst>
          </p:cNvPr>
          <p:cNvSpPr txBox="1"/>
          <p:nvPr/>
        </p:nvSpPr>
        <p:spPr>
          <a:xfrm>
            <a:off x="942975" y="4870372"/>
            <a:ext cx="72199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3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ffect of products secreted by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rowth.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 Effect of the supernatant from co-culture of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rowth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aecalibacterium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as cultured in the absence or presence of the supernatant at a concentration of 12.5%, 25%, or 50%. (B) Co-culture of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The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acteria were co-cultured in a </a:t>
            </a:r>
            <a:r>
              <a:rPr lang="en-US" altLang="ja-JP" sz="1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UniWells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horizontal co-culture plate (Fujifilm Wako Pure Chemical, Osaka, Japan), in which the two species are co-cultured together on one side of the plate (closed) or are separated by a filter (pore size: 0.03 </a:t>
            </a:r>
            <a:r>
              <a:rPr lang="en-US" altLang="ja-JP" sz="1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μm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r 0.6 </a:t>
            </a:r>
            <a:r>
              <a:rPr lang="en-US" altLang="ja-JP" sz="1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μm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. In both panels, the number of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lls was measured by quantitative PCR (n = 4, mean ± 1 SD).</a:t>
            </a:r>
            <a:endParaRPr lang="ja-JP" alt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7543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3E54468-9B09-4DC3-9B13-1F3E3F404107}"/>
              </a:ext>
            </a:extLst>
          </p:cNvPr>
          <p:cNvSpPr txBox="1"/>
          <p:nvPr/>
        </p:nvSpPr>
        <p:spPr>
          <a:xfrm>
            <a:off x="2114112" y="1623543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. </a:t>
            </a:r>
            <a:r>
              <a:rPr kumimoji="1" lang="en-US" altLang="ja-JP" sz="1000" i="1" dirty="0" err="1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prausnitzii</a:t>
            </a:r>
            <a:endParaRPr kumimoji="1" lang="ja-JP" altLang="en-US" sz="1000" i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C20DCA7-BBC4-7F80-CA7A-F88EED5686CE}"/>
              </a:ext>
            </a:extLst>
          </p:cNvPr>
          <p:cNvSpPr txBox="1"/>
          <p:nvPr/>
        </p:nvSpPr>
        <p:spPr>
          <a:xfrm>
            <a:off x="6150306" y="1623543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F. </a:t>
            </a:r>
            <a:r>
              <a:rPr kumimoji="1" lang="en-US" altLang="ja-JP" sz="1000" i="1" dirty="0" err="1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varium</a:t>
            </a:r>
            <a:endParaRPr kumimoji="1" lang="ja-JP" altLang="en-US" sz="1000" i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1741FB0-CBB1-D149-CA3E-71573DBBFEE8}"/>
              </a:ext>
            </a:extLst>
          </p:cNvPr>
          <p:cNvSpPr txBox="1"/>
          <p:nvPr/>
        </p:nvSpPr>
        <p:spPr>
          <a:xfrm>
            <a:off x="6708483" y="15240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Supplementary Figure 4</a:t>
            </a:r>
            <a:endParaRPr kumimoji="1" lang="ja-JP" altLang="en-US" sz="1400" b="1" dirty="0">
              <a:latin typeface="Arial" panose="020B0604020202020204" pitchFamily="34" charset="0"/>
              <a:ea typeface="HGPｺﾞｼｯｸE" panose="020B09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ACBD9F0C-63C3-321A-504A-8486A47AA537}"/>
              </a:ext>
            </a:extLst>
          </p:cNvPr>
          <p:cNvGrpSpPr/>
          <p:nvPr/>
        </p:nvGrpSpPr>
        <p:grpSpPr>
          <a:xfrm>
            <a:off x="819795" y="1869766"/>
            <a:ext cx="3497855" cy="2798285"/>
            <a:chOff x="819795" y="1869766"/>
            <a:chExt cx="3497855" cy="2798285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D826B574-3420-9F61-68BB-2F0F9FECD7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9795" y="1869766"/>
              <a:ext cx="3497855" cy="2798285"/>
            </a:xfrm>
            <a:prstGeom prst="rect">
              <a:avLst/>
            </a:prstGeom>
          </p:spPr>
        </p:pic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937DC441-10F6-0E0E-ED15-EEA59C0430B0}"/>
                </a:ext>
              </a:extLst>
            </p:cNvPr>
            <p:cNvSpPr/>
            <p:nvPr/>
          </p:nvSpPr>
          <p:spPr>
            <a:xfrm>
              <a:off x="3915867" y="4505031"/>
              <a:ext cx="246557" cy="6458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66DC5C9B-90AC-69FA-850D-9E90A8B670E1}"/>
              </a:ext>
            </a:extLst>
          </p:cNvPr>
          <p:cNvGrpSpPr/>
          <p:nvPr/>
        </p:nvGrpSpPr>
        <p:grpSpPr>
          <a:xfrm>
            <a:off x="4760611" y="1869765"/>
            <a:ext cx="3497856" cy="2798285"/>
            <a:chOff x="4760611" y="1869765"/>
            <a:chExt cx="3497856" cy="2798285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34AD9F79-89F0-0E95-82E4-8CEBF74DC8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0611" y="1869765"/>
              <a:ext cx="3497856" cy="2798285"/>
            </a:xfrm>
            <a:prstGeom prst="rect">
              <a:avLst/>
            </a:prstGeom>
          </p:spPr>
        </p:pic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4D39C707-03B3-E545-1065-386B46E31014}"/>
                </a:ext>
              </a:extLst>
            </p:cNvPr>
            <p:cNvSpPr/>
            <p:nvPr/>
          </p:nvSpPr>
          <p:spPr>
            <a:xfrm>
              <a:off x="7841754" y="4505031"/>
              <a:ext cx="246557" cy="6458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C3C04FB-7206-4E1F-0E96-F4CD89DDEC2D}"/>
              </a:ext>
            </a:extLst>
          </p:cNvPr>
          <p:cNvSpPr txBox="1"/>
          <p:nvPr/>
        </p:nvSpPr>
        <p:spPr>
          <a:xfrm>
            <a:off x="942975" y="4964166"/>
            <a:ext cx="721995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4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canning electron microscopy images of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 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ausnitzii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</a:t>
            </a:r>
            <a:r>
              <a:rPr lang="en-US" altLang="ja-JP" sz="10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. </a:t>
            </a:r>
            <a:r>
              <a:rPr lang="en-US" altLang="ja-JP" sz="10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arium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 species was cultured for 24 h; the cultures were fixed with glutaraldehyde and observed under a scanning electron microscope (JSM-7500F, JEOL, Tokyo, Japan). Scale bars, 1 </a:t>
            </a:r>
            <a:r>
              <a:rPr lang="en-US" altLang="ja-JP" sz="1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μm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endParaRPr lang="ja-JP" alt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5364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400" dirty="0" smtClean="0">
            <a:latin typeface="Arial" panose="020B0604020202020204" pitchFamily="34" charset="0"/>
            <a:ea typeface="HGPｺﾞｼｯｸE" panose="020B0900000000000000" pitchFamily="50" charset="-128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17</TotalTime>
  <Words>746</Words>
  <Application>Microsoft Office PowerPoint</Application>
  <PresentationFormat>画面に合わせる (4:3)</PresentationFormat>
  <Paragraphs>153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somi koji</dc:creator>
  <cp:lastModifiedBy>hosomi</cp:lastModifiedBy>
  <cp:revision>185</cp:revision>
  <cp:lastPrinted>2024-08-08T06:28:38Z</cp:lastPrinted>
  <dcterms:created xsi:type="dcterms:W3CDTF">2021-07-15T06:27:52Z</dcterms:created>
  <dcterms:modified xsi:type="dcterms:W3CDTF">2025-04-21T06:12:14Z</dcterms:modified>
</cp:coreProperties>
</file>